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9B7028-165B-070D-E6EB-D2AB090ED45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C57F104-C9AA-8A01-7A1D-23204EF0A5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86449B-1244-4C63-C04F-66BC88162E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7E543-2FAC-42E2-A343-9AAB6B21CC0A}" type="datetimeFigureOut">
              <a:rPr lang="en-US" smtClean="0"/>
              <a:t>10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6D7956-4A12-88E3-716A-EDAE105C99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08C00E-86C7-D6C2-482E-BDD103573B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8FA10-FE22-429E-8AF4-E946CBE3AD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79246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8AC7EF-D157-EEB3-3500-3EC28CE825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B35FC6A-8C66-A2B7-01EE-9C0B59059C8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4A1799-F3BB-C1E0-4680-27B7AEFCDB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7E543-2FAC-42E2-A343-9AAB6B21CC0A}" type="datetimeFigureOut">
              <a:rPr lang="en-US" smtClean="0"/>
              <a:t>10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E7818E-33B0-46D1-B4FE-0DD126601E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1C4C48-9C99-B9B8-4C50-FC190ADC3F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8FA10-FE22-429E-8AF4-E946CBE3AD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57760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077EB90-40F1-D798-6E5A-8B95270CA98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4EA6396-A120-5D16-546B-AB924E16AD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97280D-2314-01ED-C252-15EA8A0F1D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7E543-2FAC-42E2-A343-9AAB6B21CC0A}" type="datetimeFigureOut">
              <a:rPr lang="en-US" smtClean="0"/>
              <a:t>10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E9998F-1AB6-C544-5825-7B545341AE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0295EE-2B2E-DBD3-B38C-623E32FE0A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8FA10-FE22-429E-8AF4-E946CBE3AD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18012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E51686-ACAD-A6A2-041B-16D4CC2B45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948A07-E3A9-772F-A9FF-177C06265DF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A5C11C-5580-037A-11E7-54071AB976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7E543-2FAC-42E2-A343-9AAB6B21CC0A}" type="datetimeFigureOut">
              <a:rPr lang="en-US" smtClean="0"/>
              <a:t>10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0F54A5-CE58-B5D3-6FBD-EF2A2D904C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D40CAB-539C-73D2-B1B1-8FB6342450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8FA10-FE22-429E-8AF4-E946CBE3AD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2983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4757FA-F053-1CF7-E89D-0F34B892A8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52B43B-93D7-61DD-8A86-2E68464EC7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4FE3DC-9A50-0F51-BDFB-ECDEEF9C1F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7E543-2FAC-42E2-A343-9AAB6B21CC0A}" type="datetimeFigureOut">
              <a:rPr lang="en-US" smtClean="0"/>
              <a:t>10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C6F516-D446-0060-CE39-20DF06532B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2257C7-8AA4-ABE3-1878-5D3382A823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8FA10-FE22-429E-8AF4-E946CBE3AD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1502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7CC14C-9832-B76B-7FE4-CD2973756A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493C32A-F9C5-6CC7-836F-B9C662D00F0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B867F0C-E184-2ADF-3DDE-0562F2A02E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DE683A-2E1E-902A-25B3-717F8D7DC9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7E543-2FAC-42E2-A343-9AAB6B21CC0A}" type="datetimeFigureOut">
              <a:rPr lang="en-US" smtClean="0"/>
              <a:t>10/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CDC9C6A-0041-1F98-40BA-48FE397B53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E4346A-BEA0-E617-3666-297B46337F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8FA10-FE22-429E-8AF4-E946CBE3AD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8692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76458D-483A-C0D7-CEDE-D05030A05F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801226-B15E-9229-7709-2FCB58930D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0B8F23C-0761-2BA4-7964-81FDE32A700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09C758C-300F-814E-6DEF-BA349665410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4ED5580-29EC-16A0-1689-14FC18E2A8C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94DB623-0619-4526-518A-CADDB229D5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7E543-2FAC-42E2-A343-9AAB6B21CC0A}" type="datetimeFigureOut">
              <a:rPr lang="en-US" smtClean="0"/>
              <a:t>10/3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5695514-61FE-87D2-9243-10E45D5C11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1C4C6BF-F2E3-770B-6338-0C0D628E3F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8FA10-FE22-429E-8AF4-E946CBE3AD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2190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5CB762-F67C-E3FB-9F64-BE7B40919D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089212B-71A9-73D4-D9C3-289DEE459D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7E543-2FAC-42E2-A343-9AAB6B21CC0A}" type="datetimeFigureOut">
              <a:rPr lang="en-US" smtClean="0"/>
              <a:t>10/3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F874A6F-2DAA-A3AF-BB13-B615CDA963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5B92334-1D7F-915A-714A-B38D54F6FC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8FA10-FE22-429E-8AF4-E946CBE3AD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12065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A48B69D-5994-3962-A3F1-5A627ACB43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7E543-2FAC-42E2-A343-9AAB6B21CC0A}" type="datetimeFigureOut">
              <a:rPr lang="en-US" smtClean="0"/>
              <a:t>10/3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A958D3-E9CC-B3BD-BB4C-AB1931BAEF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93D6028-8D3E-F0D4-D4CC-1FDB90C7DF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8FA10-FE22-429E-8AF4-E946CBE3AD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0783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603BF1-EC77-E6D0-5525-DFA250C838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F077B8-5289-200E-1307-3DC625E0C23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056D46C-659E-8A35-CA96-A3ECCFFDD0B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917B735-A09F-11FA-7ACE-057513616C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7E543-2FAC-42E2-A343-9AAB6B21CC0A}" type="datetimeFigureOut">
              <a:rPr lang="en-US" smtClean="0"/>
              <a:t>10/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A02D382-B4E4-28FC-F8F1-A17E81615E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D651DA-A40F-685B-FC0A-F9B0FA5D99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8FA10-FE22-429E-8AF4-E946CBE3AD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86445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B3F832-981A-FEC5-C6F1-1E15DBB291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5185662-F556-F4F2-AFB7-7E91ABB1EFF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D324921-5A3B-7BED-99B1-5758BD1202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1670A4-921E-672E-0160-BE8C3C12C8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37E543-2FAC-42E2-A343-9AAB6B21CC0A}" type="datetimeFigureOut">
              <a:rPr lang="en-US" smtClean="0"/>
              <a:t>10/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7C001A-CE2D-A182-8472-86792CC5CB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8F65146-374C-DC3F-0B9A-E70468C2EA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8FA10-FE22-429E-8AF4-E946CBE3AD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4537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660230C-CE7D-2779-4D3B-AA83315EBE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3B95FF0-F4B0-3902-0280-F64A2E30AE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308873-F400-586B-5EA9-3030B2EE00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37E543-2FAC-42E2-A343-9AAB6B21CC0A}" type="datetimeFigureOut">
              <a:rPr lang="en-US" smtClean="0"/>
              <a:t>10/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33BF46-4668-9CA9-2A12-28156AD6866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DA4B0C-1D74-3B86-C9A1-90A0390B8ED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78FA10-FE22-429E-8AF4-E946CBE3AD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0204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eg"/><Relationship Id="rId2" Type="http://schemas.openxmlformats.org/officeDocument/2006/relationships/image" Target="../media/image21.jpe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jpe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jpeg"/><Relationship Id="rId2" Type="http://schemas.openxmlformats.org/officeDocument/2006/relationships/image" Target="../media/image24.jp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jpe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jpg"/><Relationship Id="rId2" Type="http://schemas.openxmlformats.org/officeDocument/2006/relationships/image" Target="../media/image27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9.jpg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g"/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g"/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g"/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g"/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diagram&#10;&#10;Description automatically generated">
            <a:extLst>
              <a:ext uri="{FF2B5EF4-FFF2-40B4-BE49-F238E27FC236}">
                <a16:creationId xmlns:a16="http://schemas.microsoft.com/office/drawing/2014/main" id="{AD237F91-51B1-C827-A430-76BAFA81B04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83434" y="83890"/>
            <a:ext cx="4791262" cy="6858000"/>
          </a:xfrm>
          <a:prstGeom prst="rect">
            <a:avLst/>
          </a:prstGeom>
        </p:spPr>
      </p:pic>
      <p:pic>
        <p:nvPicPr>
          <p:cNvPr id="7" name="Picture 6" descr="Text, letter&#10;&#10;Description automatically generated">
            <a:extLst>
              <a:ext uri="{FF2B5EF4-FFF2-40B4-BE49-F238E27FC236}">
                <a16:creationId xmlns:a16="http://schemas.microsoft.com/office/drawing/2014/main" id="{92C2FECD-EFF7-805F-C2EC-89D575C47E4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0816"/>
          <a:stretch/>
        </p:blipFill>
        <p:spPr>
          <a:xfrm>
            <a:off x="7066149" y="0"/>
            <a:ext cx="4983018" cy="268721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3338F99F-A135-2F76-B545-9B8A144806A9}"/>
              </a:ext>
            </a:extLst>
          </p:cNvPr>
          <p:cNvSpPr txBox="1"/>
          <p:nvPr/>
        </p:nvSpPr>
        <p:spPr>
          <a:xfrm>
            <a:off x="410547" y="233266"/>
            <a:ext cx="10617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1B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8AD10609-1D02-C6B4-4CED-0E6C80200C7D}"/>
              </a:ext>
            </a:extLst>
          </p:cNvPr>
          <p:cNvSpPr/>
          <p:nvPr/>
        </p:nvSpPr>
        <p:spPr>
          <a:xfrm>
            <a:off x="5281127" y="602598"/>
            <a:ext cx="814873" cy="76900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309854C7-0B63-B954-F37D-389C31541B89}"/>
              </a:ext>
            </a:extLst>
          </p:cNvPr>
          <p:cNvSpPr/>
          <p:nvPr/>
        </p:nvSpPr>
        <p:spPr>
          <a:xfrm>
            <a:off x="5236386" y="3420600"/>
            <a:ext cx="814873" cy="76900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589C6F07-8D96-882C-9E9A-FA4C2320A352}"/>
              </a:ext>
            </a:extLst>
          </p:cNvPr>
          <p:cNvSpPr/>
          <p:nvPr/>
        </p:nvSpPr>
        <p:spPr>
          <a:xfrm>
            <a:off x="10052815" y="602598"/>
            <a:ext cx="814873" cy="76900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86719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ece of paper with writing on it&#10;&#10;Description automatically generated with medium confidence">
            <a:extLst>
              <a:ext uri="{FF2B5EF4-FFF2-40B4-BE49-F238E27FC236}">
                <a16:creationId xmlns:a16="http://schemas.microsoft.com/office/drawing/2014/main" id="{D35504B3-32D4-54C7-1960-1FA37C75540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67157" y="343055"/>
            <a:ext cx="4443982" cy="6171890"/>
          </a:xfrm>
          <a:prstGeom prst="rect">
            <a:avLst/>
          </a:prstGeom>
        </p:spPr>
      </p:pic>
      <p:pic>
        <p:nvPicPr>
          <p:cNvPr id="7" name="Picture 6" descr="A piece of paper with writing&#10;&#10;Description automatically generated with medium confidence">
            <a:extLst>
              <a:ext uri="{FF2B5EF4-FFF2-40B4-BE49-F238E27FC236}">
                <a16:creationId xmlns:a16="http://schemas.microsoft.com/office/drawing/2014/main" id="{97A1AECA-CE1A-D45C-841E-2E8E865DCBF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2789" y="343055"/>
            <a:ext cx="5114368" cy="643314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F8DA27B-8753-0934-0C16-E879C4BC2177}"/>
              </a:ext>
            </a:extLst>
          </p:cNvPr>
          <p:cNvSpPr txBox="1"/>
          <p:nvPr/>
        </p:nvSpPr>
        <p:spPr>
          <a:xfrm>
            <a:off x="80861" y="1268963"/>
            <a:ext cx="22375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 7A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5C7BC138-574D-DC00-A111-B371AB09D86B}"/>
              </a:ext>
            </a:extLst>
          </p:cNvPr>
          <p:cNvSpPr/>
          <p:nvPr/>
        </p:nvSpPr>
        <p:spPr>
          <a:xfrm>
            <a:off x="3816991" y="4627984"/>
            <a:ext cx="553673" cy="12782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B8FB6722-4293-816A-BE93-1758FC3CAC13}"/>
              </a:ext>
            </a:extLst>
          </p:cNvPr>
          <p:cNvSpPr/>
          <p:nvPr/>
        </p:nvSpPr>
        <p:spPr>
          <a:xfrm>
            <a:off x="3751277" y="629816"/>
            <a:ext cx="484421" cy="127829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9D1A7391-266E-B041-BD02-86209EA250B6}"/>
              </a:ext>
            </a:extLst>
          </p:cNvPr>
          <p:cNvSpPr/>
          <p:nvPr/>
        </p:nvSpPr>
        <p:spPr>
          <a:xfrm>
            <a:off x="8623398" y="4387441"/>
            <a:ext cx="484421" cy="93725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50574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, whiteboard&#10;&#10;Description automatically generated">
            <a:extLst>
              <a:ext uri="{FF2B5EF4-FFF2-40B4-BE49-F238E27FC236}">
                <a16:creationId xmlns:a16="http://schemas.microsoft.com/office/drawing/2014/main" id="{CC9367D0-1ECB-B030-E582-D8757BC6721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33747" y="234892"/>
            <a:ext cx="5245189" cy="6539218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982A183-6F05-4287-6E17-F0681494C4B7}"/>
              </a:ext>
            </a:extLst>
          </p:cNvPr>
          <p:cNvSpPr txBox="1"/>
          <p:nvPr/>
        </p:nvSpPr>
        <p:spPr>
          <a:xfrm>
            <a:off x="1652631" y="1115736"/>
            <a:ext cx="22279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 7C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8D3132FE-38DF-CD9A-1E9B-918588023BC3}"/>
              </a:ext>
            </a:extLst>
          </p:cNvPr>
          <p:cNvSpPr/>
          <p:nvPr/>
        </p:nvSpPr>
        <p:spPr>
          <a:xfrm>
            <a:off x="7835317" y="729842"/>
            <a:ext cx="704676" cy="17281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D8420C86-3961-B2D6-2346-FBCE741E7495}"/>
              </a:ext>
            </a:extLst>
          </p:cNvPr>
          <p:cNvSpPr/>
          <p:nvPr/>
        </p:nvSpPr>
        <p:spPr>
          <a:xfrm>
            <a:off x="7635379" y="4110606"/>
            <a:ext cx="704676" cy="108218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946429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piece of paper with writing on it&#10;&#10;Description automatically generated with medium confidence">
            <a:extLst>
              <a:ext uri="{FF2B5EF4-FFF2-40B4-BE49-F238E27FC236}">
                <a16:creationId xmlns:a16="http://schemas.microsoft.com/office/drawing/2014/main" id="{B6B52919-4770-3BE2-13CE-194C4227AA9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2262" y="2793534"/>
            <a:ext cx="5210425" cy="3452068"/>
          </a:xfrm>
          <a:prstGeom prst="rect">
            <a:avLst/>
          </a:prstGeom>
        </p:spPr>
      </p:pic>
      <p:pic>
        <p:nvPicPr>
          <p:cNvPr id="6" name="Picture 5" descr="A piece of paper with writing on it&#10;&#10;Description automatically generated with medium confidence">
            <a:extLst>
              <a:ext uri="{FF2B5EF4-FFF2-40B4-BE49-F238E27FC236}">
                <a16:creationId xmlns:a16="http://schemas.microsoft.com/office/drawing/2014/main" id="{56666D7A-E596-219D-56D0-78F0933FA28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71472" y="138418"/>
            <a:ext cx="4952080" cy="658116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611D28B1-BC1D-84EE-0EA4-CFB345E9077E}"/>
              </a:ext>
            </a:extLst>
          </p:cNvPr>
          <p:cNvSpPr txBox="1"/>
          <p:nvPr/>
        </p:nvSpPr>
        <p:spPr>
          <a:xfrm>
            <a:off x="268448" y="746620"/>
            <a:ext cx="22279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 7C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DCD03D8E-9213-3197-78C7-64EC1FA76E63}"/>
              </a:ext>
            </a:extLst>
          </p:cNvPr>
          <p:cNvSpPr/>
          <p:nvPr/>
        </p:nvSpPr>
        <p:spPr>
          <a:xfrm>
            <a:off x="3229761" y="3540154"/>
            <a:ext cx="545285" cy="100667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C650858E-3942-D912-DE4A-860FD99B4B13}"/>
              </a:ext>
            </a:extLst>
          </p:cNvPr>
          <p:cNvSpPr/>
          <p:nvPr/>
        </p:nvSpPr>
        <p:spPr>
          <a:xfrm>
            <a:off x="9346733" y="612612"/>
            <a:ext cx="545285" cy="100667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32C67B6B-8305-3C73-0E53-A3609A718B7D}"/>
              </a:ext>
            </a:extLst>
          </p:cNvPr>
          <p:cNvSpPr/>
          <p:nvPr/>
        </p:nvSpPr>
        <p:spPr>
          <a:xfrm>
            <a:off x="9346733" y="3666096"/>
            <a:ext cx="545285" cy="100667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669875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age of a book&#10;&#10;Description automatically generated with low confidence">
            <a:extLst>
              <a:ext uri="{FF2B5EF4-FFF2-40B4-BE49-F238E27FC236}">
                <a16:creationId xmlns:a16="http://schemas.microsoft.com/office/drawing/2014/main" id="{D4A47AC6-32D0-0C37-E136-D6D81E55A89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67871" y="242595"/>
            <a:ext cx="4659388" cy="653142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3994206-EA24-2A9C-3247-7DF608DDB550}"/>
              </a:ext>
            </a:extLst>
          </p:cNvPr>
          <p:cNvSpPr txBox="1"/>
          <p:nvPr/>
        </p:nvSpPr>
        <p:spPr>
          <a:xfrm>
            <a:off x="1119673" y="1847461"/>
            <a:ext cx="22471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 8D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61577F49-8BB3-EF36-8356-09E54EA408AF}"/>
              </a:ext>
            </a:extLst>
          </p:cNvPr>
          <p:cNvSpPr/>
          <p:nvPr/>
        </p:nvSpPr>
        <p:spPr>
          <a:xfrm>
            <a:off x="8662575" y="531845"/>
            <a:ext cx="522514" cy="79361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70B0482E-DF03-160F-BB19-B66DB24AD7C4}"/>
              </a:ext>
            </a:extLst>
          </p:cNvPr>
          <p:cNvSpPr/>
          <p:nvPr/>
        </p:nvSpPr>
        <p:spPr>
          <a:xfrm>
            <a:off x="8662575" y="4027716"/>
            <a:ext cx="522514" cy="107302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583638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Text, letter&#10;&#10;Description automatically generated">
            <a:extLst>
              <a:ext uri="{FF2B5EF4-FFF2-40B4-BE49-F238E27FC236}">
                <a16:creationId xmlns:a16="http://schemas.microsoft.com/office/drawing/2014/main" id="{669DCA8C-4443-AA78-5557-BB0F7855CCB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65731" y="239086"/>
            <a:ext cx="5041527" cy="6379828"/>
          </a:xfrm>
          <a:prstGeom prst="rect">
            <a:avLst/>
          </a:prstGeom>
        </p:spPr>
      </p:pic>
      <p:pic>
        <p:nvPicPr>
          <p:cNvPr id="7" name="Picture 6" descr="A picture containing text, whiteboard&#10;&#10;Description automatically generated">
            <a:extLst>
              <a:ext uri="{FF2B5EF4-FFF2-40B4-BE49-F238E27FC236}">
                <a16:creationId xmlns:a16="http://schemas.microsoft.com/office/drawing/2014/main" id="{FFCAA0E2-011C-94F3-CAD7-14B24FE491F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6134" y="3429000"/>
            <a:ext cx="4874695" cy="3317670"/>
          </a:xfrm>
          <a:prstGeom prst="rect">
            <a:avLst/>
          </a:prstGeom>
        </p:spPr>
      </p:pic>
      <p:pic>
        <p:nvPicPr>
          <p:cNvPr id="9" name="Picture 8" descr="A picture containing text, whiteboard&#10;&#10;Description automatically generated">
            <a:extLst>
              <a:ext uri="{FF2B5EF4-FFF2-40B4-BE49-F238E27FC236}">
                <a16:creationId xmlns:a16="http://schemas.microsoft.com/office/drawing/2014/main" id="{58BFC60B-CF3B-6ACF-3C80-FFA43A07BC0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7180" y="110027"/>
            <a:ext cx="4911100" cy="3318973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42DF8A3C-78D2-3962-A645-4F3F4452C757}"/>
              </a:ext>
            </a:extLst>
          </p:cNvPr>
          <p:cNvSpPr txBox="1"/>
          <p:nvPr/>
        </p:nvSpPr>
        <p:spPr>
          <a:xfrm>
            <a:off x="8388" y="1031846"/>
            <a:ext cx="166686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</a:t>
            </a:r>
          </a:p>
          <a:p>
            <a:r>
              <a:rPr lang="en-US" dirty="0"/>
              <a:t>Fig 8E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823E3575-FE42-0DAE-E5C0-98482D6240A0}"/>
              </a:ext>
            </a:extLst>
          </p:cNvPr>
          <p:cNvSpPr/>
          <p:nvPr/>
        </p:nvSpPr>
        <p:spPr>
          <a:xfrm>
            <a:off x="3825380" y="3867325"/>
            <a:ext cx="1015068" cy="8053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54E01D8B-E23B-F6C9-5091-78659AFACCCD}"/>
              </a:ext>
            </a:extLst>
          </p:cNvPr>
          <p:cNvSpPr/>
          <p:nvPr/>
        </p:nvSpPr>
        <p:spPr>
          <a:xfrm>
            <a:off x="3893481" y="1209413"/>
            <a:ext cx="1015068" cy="8053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3B736196-50E4-F6F4-D5F6-7D3F5B982961}"/>
              </a:ext>
            </a:extLst>
          </p:cNvPr>
          <p:cNvSpPr/>
          <p:nvPr/>
        </p:nvSpPr>
        <p:spPr>
          <a:xfrm>
            <a:off x="8986007" y="1068459"/>
            <a:ext cx="1015068" cy="8053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3FD5B677-621F-8EDB-7BCD-3E786221C80D}"/>
              </a:ext>
            </a:extLst>
          </p:cNvPr>
          <p:cNvSpPr/>
          <p:nvPr/>
        </p:nvSpPr>
        <p:spPr>
          <a:xfrm>
            <a:off x="8986007" y="3776444"/>
            <a:ext cx="1015068" cy="8053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020340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ece of paper with writing on it&#10;&#10;Description automatically generated with medium confidence">
            <a:extLst>
              <a:ext uri="{FF2B5EF4-FFF2-40B4-BE49-F238E27FC236}">
                <a16:creationId xmlns:a16="http://schemas.microsoft.com/office/drawing/2014/main" id="{E9A51FCE-87E9-EEA8-4BCA-C6AEB60313A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54728" y="285226"/>
            <a:ext cx="5023981" cy="643016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3152AFB-4ADC-8F16-776B-E5D83E951007}"/>
              </a:ext>
            </a:extLst>
          </p:cNvPr>
          <p:cNvSpPr txBox="1"/>
          <p:nvPr/>
        </p:nvSpPr>
        <p:spPr>
          <a:xfrm>
            <a:off x="1040235" y="1619075"/>
            <a:ext cx="22102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 8F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465D310E-DD52-9F89-FC92-47DA0AC7B646}"/>
              </a:ext>
            </a:extLst>
          </p:cNvPr>
          <p:cNvSpPr/>
          <p:nvPr/>
        </p:nvSpPr>
        <p:spPr>
          <a:xfrm>
            <a:off x="7617204" y="494950"/>
            <a:ext cx="721453" cy="156874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31424469-A51D-05F2-E245-8682F50E1A97}"/>
              </a:ext>
            </a:extLst>
          </p:cNvPr>
          <p:cNvSpPr/>
          <p:nvPr/>
        </p:nvSpPr>
        <p:spPr>
          <a:xfrm>
            <a:off x="6786694" y="4429387"/>
            <a:ext cx="680906" cy="77318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1254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&#10;&#10;Description automatically generated">
            <a:extLst>
              <a:ext uri="{FF2B5EF4-FFF2-40B4-BE49-F238E27FC236}">
                <a16:creationId xmlns:a16="http://schemas.microsoft.com/office/drawing/2014/main" id="{D5279B7F-2056-B836-4E31-2F0D01B5721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6487" y="240581"/>
            <a:ext cx="5232669" cy="3188419"/>
          </a:xfrm>
          <a:prstGeom prst="rect">
            <a:avLst/>
          </a:prstGeom>
        </p:spPr>
      </p:pic>
      <p:pic>
        <p:nvPicPr>
          <p:cNvPr id="7" name="Picture 6" descr="A picture containing text, whiteboard&#10;&#10;Description automatically generated">
            <a:extLst>
              <a:ext uri="{FF2B5EF4-FFF2-40B4-BE49-F238E27FC236}">
                <a16:creationId xmlns:a16="http://schemas.microsoft.com/office/drawing/2014/main" id="{7D6B8D6B-9E32-CE7F-C254-EED7D53D5C9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6487" y="3566944"/>
            <a:ext cx="5629316" cy="3188420"/>
          </a:xfrm>
          <a:prstGeom prst="rect">
            <a:avLst/>
          </a:prstGeom>
        </p:spPr>
      </p:pic>
      <p:pic>
        <p:nvPicPr>
          <p:cNvPr id="9" name="Picture 8" descr="A picture containing text, whiteboard&#10;&#10;Description automatically generated">
            <a:extLst>
              <a:ext uri="{FF2B5EF4-FFF2-40B4-BE49-F238E27FC236}">
                <a16:creationId xmlns:a16="http://schemas.microsoft.com/office/drawing/2014/main" id="{31BE7A5B-FA0E-EAC9-A8AA-9ADD9BFA5C0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0376" y="240581"/>
            <a:ext cx="5629316" cy="289635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70643E63-D36C-4082-3457-7277A34F8D3A}"/>
              </a:ext>
            </a:extLst>
          </p:cNvPr>
          <p:cNvSpPr txBox="1"/>
          <p:nvPr/>
        </p:nvSpPr>
        <p:spPr>
          <a:xfrm>
            <a:off x="142308" y="510996"/>
            <a:ext cx="1034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1L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35631083-3007-BEB7-14D9-8F27872F46C6}"/>
              </a:ext>
            </a:extLst>
          </p:cNvPr>
          <p:cNvSpPr/>
          <p:nvPr/>
        </p:nvSpPr>
        <p:spPr>
          <a:xfrm>
            <a:off x="2907898" y="1994736"/>
            <a:ext cx="2108718" cy="6531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72EAB771-0053-094D-5793-544AA40CE558}"/>
              </a:ext>
            </a:extLst>
          </p:cNvPr>
          <p:cNvSpPr/>
          <p:nvPr/>
        </p:nvSpPr>
        <p:spPr>
          <a:xfrm>
            <a:off x="3085465" y="5050928"/>
            <a:ext cx="2108718" cy="6531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94D560B3-67E6-A601-5B46-75379CD9C14D}"/>
              </a:ext>
            </a:extLst>
          </p:cNvPr>
          <p:cNvSpPr/>
          <p:nvPr/>
        </p:nvSpPr>
        <p:spPr>
          <a:xfrm>
            <a:off x="8036618" y="953130"/>
            <a:ext cx="2013393" cy="6531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2314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piece of paper with writing&#10;&#10;Description automatically generated with medium confidence">
            <a:extLst>
              <a:ext uri="{FF2B5EF4-FFF2-40B4-BE49-F238E27FC236}">
                <a16:creationId xmlns:a16="http://schemas.microsoft.com/office/drawing/2014/main" id="{5848A47D-A88E-2708-2787-292A3A1AB39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6253254" y="102636"/>
            <a:ext cx="5880716" cy="6652727"/>
          </a:xfrm>
          <a:prstGeom prst="rect">
            <a:avLst/>
          </a:prstGeom>
        </p:spPr>
      </p:pic>
      <p:pic>
        <p:nvPicPr>
          <p:cNvPr id="5" name="Picture 4" descr="A picture containing text&#10;&#10;Description automatically generated">
            <a:extLst>
              <a:ext uri="{FF2B5EF4-FFF2-40B4-BE49-F238E27FC236}">
                <a16:creationId xmlns:a16="http://schemas.microsoft.com/office/drawing/2014/main" id="{08618C49-790F-F54F-1D5D-56B92D41A5B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322489" y="2570960"/>
            <a:ext cx="5773511" cy="373251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88E3E43D-329B-D13C-7ABC-A764223F5DE9}"/>
              </a:ext>
            </a:extLst>
          </p:cNvPr>
          <p:cNvSpPr txBox="1"/>
          <p:nvPr/>
        </p:nvSpPr>
        <p:spPr>
          <a:xfrm>
            <a:off x="824159" y="554528"/>
            <a:ext cx="22471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 2D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4C115083-2A54-EFBC-1989-E784A8C8CCAF}"/>
              </a:ext>
            </a:extLst>
          </p:cNvPr>
          <p:cNvSpPr/>
          <p:nvPr/>
        </p:nvSpPr>
        <p:spPr>
          <a:xfrm>
            <a:off x="2315360" y="3028426"/>
            <a:ext cx="444617" cy="85567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32C159AC-1F76-DBF8-C733-0E37E9D120E6}"/>
              </a:ext>
            </a:extLst>
          </p:cNvPr>
          <p:cNvSpPr/>
          <p:nvPr/>
        </p:nvSpPr>
        <p:spPr>
          <a:xfrm>
            <a:off x="7843707" y="1434517"/>
            <a:ext cx="454404" cy="81513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660A1C71-7820-23C2-A413-EDB23F5AB075}"/>
              </a:ext>
            </a:extLst>
          </p:cNvPr>
          <p:cNvSpPr/>
          <p:nvPr/>
        </p:nvSpPr>
        <p:spPr>
          <a:xfrm>
            <a:off x="7877263" y="4437216"/>
            <a:ext cx="454404" cy="81513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20825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ece of paper with writing on it&#10;&#10;Description automatically generated with medium confidence">
            <a:extLst>
              <a:ext uri="{FF2B5EF4-FFF2-40B4-BE49-F238E27FC236}">
                <a16:creationId xmlns:a16="http://schemas.microsoft.com/office/drawing/2014/main" id="{49C65C3C-6FDE-FEC5-657E-516A6CDB791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85957" y="120616"/>
            <a:ext cx="5326954" cy="3740764"/>
          </a:xfrm>
          <a:prstGeom prst="rect">
            <a:avLst/>
          </a:prstGeom>
        </p:spPr>
      </p:pic>
      <p:pic>
        <p:nvPicPr>
          <p:cNvPr id="7" name="Picture 6" descr="A piece of paper with writing&#10;&#10;Description automatically generated with medium confidence">
            <a:extLst>
              <a:ext uri="{FF2B5EF4-FFF2-40B4-BE49-F238E27FC236}">
                <a16:creationId xmlns:a16="http://schemas.microsoft.com/office/drawing/2014/main" id="{2F3D945B-4032-3AC6-8A42-319166378C1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2779" y="2991663"/>
            <a:ext cx="5326953" cy="3866337"/>
          </a:xfrm>
          <a:prstGeom prst="rect">
            <a:avLst/>
          </a:prstGeom>
        </p:spPr>
      </p:pic>
      <p:pic>
        <p:nvPicPr>
          <p:cNvPr id="9" name="Picture 8" descr="A piece of paper with writing&#10;&#10;Description automatically generated with medium confidence">
            <a:extLst>
              <a:ext uri="{FF2B5EF4-FFF2-40B4-BE49-F238E27FC236}">
                <a16:creationId xmlns:a16="http://schemas.microsoft.com/office/drawing/2014/main" id="{DEDA455C-5C01-89DC-E16F-D5E00D10F94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59521" y="3260985"/>
            <a:ext cx="5353390" cy="3476399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96024BEA-C47A-CEB9-0AF5-D53182D7714C}"/>
              </a:ext>
            </a:extLst>
          </p:cNvPr>
          <p:cNvSpPr txBox="1"/>
          <p:nvPr/>
        </p:nvSpPr>
        <p:spPr>
          <a:xfrm>
            <a:off x="1688841" y="643812"/>
            <a:ext cx="22166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 3E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CF925CD4-A2DA-1143-A406-E0CCE06F669A}"/>
              </a:ext>
            </a:extLst>
          </p:cNvPr>
          <p:cNvSpPr/>
          <p:nvPr/>
        </p:nvSpPr>
        <p:spPr>
          <a:xfrm>
            <a:off x="2541865" y="4538443"/>
            <a:ext cx="2323750" cy="3881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DDE6F201-8D14-3C4C-4F46-C4E6E459814C}"/>
              </a:ext>
            </a:extLst>
          </p:cNvPr>
          <p:cNvSpPr/>
          <p:nvPr/>
        </p:nvSpPr>
        <p:spPr>
          <a:xfrm>
            <a:off x="8096775" y="1392572"/>
            <a:ext cx="2323750" cy="65434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EEE5D86E-FC14-0595-A43A-F5CBE8F483C2}"/>
              </a:ext>
            </a:extLst>
          </p:cNvPr>
          <p:cNvSpPr/>
          <p:nvPr/>
        </p:nvSpPr>
        <p:spPr>
          <a:xfrm>
            <a:off x="8039451" y="4538443"/>
            <a:ext cx="2323750" cy="38811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96835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Text, letter&#10;&#10;Description automatically generated">
            <a:extLst>
              <a:ext uri="{FF2B5EF4-FFF2-40B4-BE49-F238E27FC236}">
                <a16:creationId xmlns:a16="http://schemas.microsoft.com/office/drawing/2014/main" id="{482BCF00-370F-05D7-D000-1832190725B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9829" y="111154"/>
            <a:ext cx="5607235" cy="6635692"/>
          </a:xfrm>
          <a:prstGeom prst="rect">
            <a:avLst/>
          </a:prstGeom>
        </p:spPr>
      </p:pic>
      <p:pic>
        <p:nvPicPr>
          <p:cNvPr id="5" name="Picture 4" descr="Text&#10;&#10;Description automatically generated with low confidence">
            <a:extLst>
              <a:ext uri="{FF2B5EF4-FFF2-40B4-BE49-F238E27FC236}">
                <a16:creationId xmlns:a16="http://schemas.microsoft.com/office/drawing/2014/main" id="{71D30CB9-249C-3C04-E7CA-FCCA467C199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0117" y="3258955"/>
            <a:ext cx="5693376" cy="321557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125D4DF-69B7-1A10-1CDE-738C6D728F37}"/>
              </a:ext>
            </a:extLst>
          </p:cNvPr>
          <p:cNvSpPr txBox="1"/>
          <p:nvPr/>
        </p:nvSpPr>
        <p:spPr>
          <a:xfrm>
            <a:off x="889232" y="755009"/>
            <a:ext cx="22375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 4A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79C44D8D-90E1-F523-9224-01795315439F}"/>
              </a:ext>
            </a:extLst>
          </p:cNvPr>
          <p:cNvSpPr/>
          <p:nvPr/>
        </p:nvSpPr>
        <p:spPr>
          <a:xfrm>
            <a:off x="2130804" y="4974672"/>
            <a:ext cx="2676088" cy="6207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FBC40E31-8979-0C5A-B3D8-A99FA035CAEA}"/>
              </a:ext>
            </a:extLst>
          </p:cNvPr>
          <p:cNvSpPr/>
          <p:nvPr/>
        </p:nvSpPr>
        <p:spPr>
          <a:xfrm>
            <a:off x="8054830" y="764797"/>
            <a:ext cx="2676088" cy="6207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AF8F159F-BD29-964A-DF27-5A90B63A9241}"/>
              </a:ext>
            </a:extLst>
          </p:cNvPr>
          <p:cNvSpPr/>
          <p:nvPr/>
        </p:nvSpPr>
        <p:spPr>
          <a:xfrm>
            <a:off x="8054830" y="3969392"/>
            <a:ext cx="2676088" cy="6207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641345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piece of paper with writing on it&#10;&#10;Description automatically generated">
            <a:extLst>
              <a:ext uri="{FF2B5EF4-FFF2-40B4-BE49-F238E27FC236}">
                <a16:creationId xmlns:a16="http://schemas.microsoft.com/office/drawing/2014/main" id="{2705BD40-CA73-CC26-0232-21661222CD0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02848" y="65314"/>
            <a:ext cx="5093476" cy="6727371"/>
          </a:xfrm>
          <a:prstGeom prst="rect">
            <a:avLst/>
          </a:prstGeom>
        </p:spPr>
      </p:pic>
      <p:pic>
        <p:nvPicPr>
          <p:cNvPr id="5" name="Picture 4" descr="A piece of paper with writing on it&#10;&#10;Description automatically generated with medium confidence">
            <a:extLst>
              <a:ext uri="{FF2B5EF4-FFF2-40B4-BE49-F238E27FC236}">
                <a16:creationId xmlns:a16="http://schemas.microsoft.com/office/drawing/2014/main" id="{28AC4EFA-D0EF-6F90-C6FF-AB2C5380AED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4786" y="3184574"/>
            <a:ext cx="5246983" cy="360811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CE348180-6FCC-6C51-FB0F-F070D82D7C63}"/>
              </a:ext>
            </a:extLst>
          </p:cNvPr>
          <p:cNvSpPr txBox="1"/>
          <p:nvPr/>
        </p:nvSpPr>
        <p:spPr>
          <a:xfrm>
            <a:off x="1418253" y="1045029"/>
            <a:ext cx="36296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 5D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7E2BE1F6-525A-80B0-7E99-14EEC248CB57}"/>
              </a:ext>
            </a:extLst>
          </p:cNvPr>
          <p:cNvSpPr/>
          <p:nvPr/>
        </p:nvSpPr>
        <p:spPr>
          <a:xfrm>
            <a:off x="3116424" y="4478694"/>
            <a:ext cx="597160" cy="8304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73A5D6C0-C0EE-0537-A4AB-7CA7DF7D5E2B}"/>
              </a:ext>
            </a:extLst>
          </p:cNvPr>
          <p:cNvSpPr/>
          <p:nvPr/>
        </p:nvSpPr>
        <p:spPr>
          <a:xfrm>
            <a:off x="8897837" y="583937"/>
            <a:ext cx="597160" cy="8304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F782ABCB-EBE6-C1FC-767F-1FD5AA149E66}"/>
              </a:ext>
            </a:extLst>
          </p:cNvPr>
          <p:cNvSpPr/>
          <p:nvPr/>
        </p:nvSpPr>
        <p:spPr>
          <a:xfrm>
            <a:off x="8811149" y="3884474"/>
            <a:ext cx="597160" cy="8304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96083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Text, letter&#10;&#10;Description automatically generated">
            <a:extLst>
              <a:ext uri="{FF2B5EF4-FFF2-40B4-BE49-F238E27FC236}">
                <a16:creationId xmlns:a16="http://schemas.microsoft.com/office/drawing/2014/main" id="{6C0CFBF0-1E12-2680-6500-DF51F80A80E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82839" y="318782"/>
            <a:ext cx="4758783" cy="606095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7C358AC-35CD-5024-56C3-A85A2BFD8E9D}"/>
              </a:ext>
            </a:extLst>
          </p:cNvPr>
          <p:cNvSpPr txBox="1"/>
          <p:nvPr/>
        </p:nvSpPr>
        <p:spPr>
          <a:xfrm>
            <a:off x="1166070" y="1115736"/>
            <a:ext cx="22102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 5F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12C33D54-383C-8E4D-BF4F-48B011B47A7C}"/>
              </a:ext>
            </a:extLst>
          </p:cNvPr>
          <p:cNvSpPr/>
          <p:nvPr/>
        </p:nvSpPr>
        <p:spPr>
          <a:xfrm>
            <a:off x="7197754" y="637563"/>
            <a:ext cx="520118" cy="10402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3D5B6109-57AD-6EDA-F0C9-6D0B3EB120DA}"/>
              </a:ext>
            </a:extLst>
          </p:cNvPr>
          <p:cNvSpPr/>
          <p:nvPr/>
        </p:nvSpPr>
        <p:spPr>
          <a:xfrm>
            <a:off x="7215930" y="3601626"/>
            <a:ext cx="594220" cy="132271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9" name="Picture 8" descr="A picture containing text, whiteboard&#10;&#10;Description automatically generated">
            <a:extLst>
              <a:ext uri="{FF2B5EF4-FFF2-40B4-BE49-F238E27FC236}">
                <a16:creationId xmlns:a16="http://schemas.microsoft.com/office/drawing/2014/main" id="{BAE2663D-6B4D-A92B-73EF-217F67AECF6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654" y="3489820"/>
            <a:ext cx="4624804" cy="2380016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0F89AEEA-5196-6CD6-03FC-96479C47C290}"/>
              </a:ext>
            </a:extLst>
          </p:cNvPr>
          <p:cNvSpPr/>
          <p:nvPr/>
        </p:nvSpPr>
        <p:spPr>
          <a:xfrm>
            <a:off x="2298583" y="3804360"/>
            <a:ext cx="553674" cy="79280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756847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-up of a document&#10;&#10;Description automatically generated with low confidence">
            <a:extLst>
              <a:ext uri="{FF2B5EF4-FFF2-40B4-BE49-F238E27FC236}">
                <a16:creationId xmlns:a16="http://schemas.microsoft.com/office/drawing/2014/main" id="{95E5F003-4F59-75F6-83EF-0B233794CD7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17716" y="217429"/>
            <a:ext cx="4993043" cy="6372808"/>
          </a:xfrm>
          <a:prstGeom prst="rect">
            <a:avLst/>
          </a:prstGeom>
        </p:spPr>
      </p:pic>
      <p:pic>
        <p:nvPicPr>
          <p:cNvPr id="7" name="Picture 6" descr="A piece of paper with writing on it&#10;&#10;Description automatically generated with medium confidence">
            <a:extLst>
              <a:ext uri="{FF2B5EF4-FFF2-40B4-BE49-F238E27FC236}">
                <a16:creationId xmlns:a16="http://schemas.microsoft.com/office/drawing/2014/main" id="{DF9A5551-0C8A-1D6A-560B-ED280D36598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7089" y="3339870"/>
            <a:ext cx="4993043" cy="327553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9D512A5-F5DA-7C36-F8F4-614180A3B62A}"/>
              </a:ext>
            </a:extLst>
          </p:cNvPr>
          <p:cNvSpPr txBox="1"/>
          <p:nvPr/>
        </p:nvSpPr>
        <p:spPr>
          <a:xfrm>
            <a:off x="1726163" y="1063690"/>
            <a:ext cx="22487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 5H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199A9C5B-174B-4697-EA2A-D28CD009387F}"/>
              </a:ext>
            </a:extLst>
          </p:cNvPr>
          <p:cNvSpPr/>
          <p:nvPr/>
        </p:nvSpPr>
        <p:spPr>
          <a:xfrm>
            <a:off x="7793372" y="4504888"/>
            <a:ext cx="595619" cy="8053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3B43327E-44BC-B07E-0B84-2075C8E9B85D}"/>
              </a:ext>
            </a:extLst>
          </p:cNvPr>
          <p:cNvSpPr/>
          <p:nvPr/>
        </p:nvSpPr>
        <p:spPr>
          <a:xfrm>
            <a:off x="7998902" y="1076944"/>
            <a:ext cx="595619" cy="8053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5D881E3C-530F-6D65-71C4-2C22E181106B}"/>
              </a:ext>
            </a:extLst>
          </p:cNvPr>
          <p:cNvSpPr/>
          <p:nvPr/>
        </p:nvSpPr>
        <p:spPr>
          <a:xfrm>
            <a:off x="2140590" y="5496187"/>
            <a:ext cx="595619" cy="80534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754370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, whiteboard&#10;&#10;Description automatically generated">
            <a:extLst>
              <a:ext uri="{FF2B5EF4-FFF2-40B4-BE49-F238E27FC236}">
                <a16:creationId xmlns:a16="http://schemas.microsoft.com/office/drawing/2014/main" id="{6075A3CC-B077-09C1-8F1C-E1A55693AB2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45560" y="108225"/>
            <a:ext cx="5059807" cy="6522440"/>
          </a:xfrm>
          <a:prstGeom prst="rect">
            <a:avLst/>
          </a:prstGeom>
        </p:spPr>
      </p:pic>
      <p:pic>
        <p:nvPicPr>
          <p:cNvPr id="7" name="Picture 6" descr="A picture containing text, whiteboard&#10;&#10;Description automatically generated">
            <a:extLst>
              <a:ext uri="{FF2B5EF4-FFF2-40B4-BE49-F238E27FC236}">
                <a16:creationId xmlns:a16="http://schemas.microsoft.com/office/drawing/2014/main" id="{BD9D9DD8-88FA-F39C-CD4E-AA2A6DD8F91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5925" y="2949164"/>
            <a:ext cx="5150516" cy="368150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6DEBFC0-B41D-FBD7-1910-3FC958B3BB3C}"/>
              </a:ext>
            </a:extLst>
          </p:cNvPr>
          <p:cNvSpPr txBox="1"/>
          <p:nvPr/>
        </p:nvSpPr>
        <p:spPr>
          <a:xfrm>
            <a:off x="1157680" y="931178"/>
            <a:ext cx="22375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 7A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B94E5A65-B9F3-E383-9326-DE453E26237E}"/>
              </a:ext>
            </a:extLst>
          </p:cNvPr>
          <p:cNvSpPr/>
          <p:nvPr/>
        </p:nvSpPr>
        <p:spPr>
          <a:xfrm>
            <a:off x="3028426" y="3775046"/>
            <a:ext cx="453005" cy="51172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62E131DB-2C43-EB50-8C3A-E2A79D340E01}"/>
              </a:ext>
            </a:extLst>
          </p:cNvPr>
          <p:cNvSpPr/>
          <p:nvPr/>
        </p:nvSpPr>
        <p:spPr>
          <a:xfrm>
            <a:off x="8029663" y="654341"/>
            <a:ext cx="453005" cy="6475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08F592DC-E5EC-9310-53DB-6C6A028B4542}"/>
              </a:ext>
            </a:extLst>
          </p:cNvPr>
          <p:cNvSpPr/>
          <p:nvPr/>
        </p:nvSpPr>
        <p:spPr>
          <a:xfrm>
            <a:off x="8710569" y="3962990"/>
            <a:ext cx="453005" cy="64756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90465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</TotalTime>
  <Words>43</Words>
  <Application>Microsoft Office PowerPoint</Application>
  <PresentationFormat>Widescreen</PresentationFormat>
  <Paragraphs>16</Paragraphs>
  <Slides>1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1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he Ohio State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ovat, Francesca</dc:creator>
  <cp:lastModifiedBy>Lovat, Francesca</cp:lastModifiedBy>
  <cp:revision>2</cp:revision>
  <dcterms:created xsi:type="dcterms:W3CDTF">2022-09-30T11:51:33Z</dcterms:created>
  <dcterms:modified xsi:type="dcterms:W3CDTF">2022-10-03T13:25:25Z</dcterms:modified>
</cp:coreProperties>
</file>